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10.png" ContentType="image/pn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8.jpeg" ContentType="image/jpe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CB14BD-4C42-4A3F-B55C-91D121B9D29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ECF072-CB53-4855-BEB1-652D518B2D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961E7E-6325-4CC1-86BA-8934379BEDC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C27B88-4144-4325-A120-7F01B25D2AB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05AB58-8CD8-4DDC-85D6-0CBFA1D2FCD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A66779-D51E-4B08-B9C0-FD0EFB01D9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30B078-5176-4EDC-949A-39C9DEAEBA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0839EE-7714-4BB6-8599-793F748B989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06D263-B0F7-4F1E-9BF6-83102CFF986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6A96C8-EC59-4ED6-BB20-9715B71358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6B2AD7-CFC1-485A-87C5-090D492B10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BA1A20-18D9-4E65-B234-DECBEAE0F7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59776E-00B6-4C04-A2A5-F95D6823AF4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85760" y="345960"/>
            <a:ext cx="6206760" cy="5921280"/>
            <a:chOff x="185760" y="345960"/>
            <a:chExt cx="6206760" cy="5921280"/>
          </a:xfrm>
        </p:grpSpPr>
        <p:sp>
          <p:nvSpPr>
            <p:cNvPr id="42" name=""/>
            <p:cNvSpPr/>
            <p:nvPr/>
          </p:nvSpPr>
          <p:spPr>
            <a:xfrm>
              <a:off x="185760" y="3846600"/>
              <a:ext cx="25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187200" y="345960"/>
              <a:ext cx="25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4" name="" descr=""/>
            <p:cNvPicPr/>
            <p:nvPr/>
          </p:nvPicPr>
          <p:blipFill>
            <a:blip r:embed="rId1"/>
            <a:stretch/>
          </p:blipFill>
          <p:spPr>
            <a:xfrm>
              <a:off x="484200" y="639720"/>
              <a:ext cx="1917720" cy="14367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45" name="" descr=""/>
            <p:cNvPicPr/>
            <p:nvPr/>
          </p:nvPicPr>
          <p:blipFill>
            <a:blip r:embed="rId2"/>
            <a:stretch/>
          </p:blipFill>
          <p:spPr>
            <a:xfrm>
              <a:off x="484200" y="2333520"/>
              <a:ext cx="1917720" cy="14385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46" name="" descr=""/>
            <p:cNvPicPr/>
            <p:nvPr/>
          </p:nvPicPr>
          <p:blipFill>
            <a:blip r:embed="rId3"/>
            <a:stretch/>
          </p:blipFill>
          <p:spPr>
            <a:xfrm>
              <a:off x="2482920" y="638280"/>
              <a:ext cx="1917720" cy="14382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47" name="" descr=""/>
            <p:cNvPicPr/>
            <p:nvPr/>
          </p:nvPicPr>
          <p:blipFill>
            <a:blip r:embed="rId4"/>
            <a:stretch/>
          </p:blipFill>
          <p:spPr>
            <a:xfrm>
              <a:off x="2482920" y="2333520"/>
              <a:ext cx="1917720" cy="14385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48" name="" descr=""/>
            <p:cNvPicPr/>
            <p:nvPr/>
          </p:nvPicPr>
          <p:blipFill>
            <a:blip r:embed="rId5"/>
            <a:stretch/>
          </p:blipFill>
          <p:spPr>
            <a:xfrm>
              <a:off x="4473720" y="639720"/>
              <a:ext cx="1917720" cy="14367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49" name="" descr=""/>
            <p:cNvPicPr/>
            <p:nvPr/>
          </p:nvPicPr>
          <p:blipFill>
            <a:blip r:embed="rId6"/>
            <a:stretch/>
          </p:blipFill>
          <p:spPr>
            <a:xfrm>
              <a:off x="4473720" y="2333520"/>
              <a:ext cx="1917720" cy="14385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50" name=""/>
            <p:cNvSpPr/>
            <p:nvPr/>
          </p:nvSpPr>
          <p:spPr>
            <a:xfrm>
              <a:off x="476280" y="457200"/>
              <a:ext cx="901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682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R&amp;D MAB 098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2481120" y="457200"/>
              <a:ext cx="703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682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SC AB N1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4470120" y="457200"/>
              <a:ext cx="692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682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SC AB F1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478080" y="2154240"/>
              <a:ext cx="1529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682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R&amp;D MAB 0983, preabsorbe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2482920" y="2154240"/>
              <a:ext cx="1331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682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SC AB N18, preabsorbe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4471920" y="2152800"/>
              <a:ext cx="1320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682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SC AB F18, preabsorbe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6" name="" descr=""/>
            <p:cNvPicPr/>
            <p:nvPr/>
          </p:nvPicPr>
          <p:blipFill>
            <a:blip r:embed="rId7"/>
            <a:stretch/>
          </p:blipFill>
          <p:spPr>
            <a:xfrm>
              <a:off x="3548160" y="1469880"/>
              <a:ext cx="849240" cy="6019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57" name="" descr=""/>
            <p:cNvPicPr/>
            <p:nvPr/>
          </p:nvPicPr>
          <p:blipFill>
            <a:blip r:embed="rId8"/>
            <a:stretch/>
          </p:blipFill>
          <p:spPr>
            <a:xfrm>
              <a:off x="3549600" y="3170160"/>
              <a:ext cx="849240" cy="6019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58" name=""/>
            <p:cNvSpPr/>
            <p:nvPr/>
          </p:nvSpPr>
          <p:spPr>
            <a:xfrm>
              <a:off x="1673280" y="714240"/>
              <a:ext cx="22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2682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1692360" y="1020600"/>
              <a:ext cx="22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2682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2016360" y="1643040"/>
              <a:ext cx="22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2682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028960" y="2511360"/>
              <a:ext cx="22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2682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1676520" y="2793960"/>
              <a:ext cx="22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2682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 flipH="1" flipV="1" rot="7373400">
              <a:off x="3719880" y="1680120"/>
              <a:ext cx="69840" cy="116280"/>
            </a:xfrm>
            <a:prstGeom prst="triangle">
              <a:avLst>
                <a:gd name="adj" fmla="val 100000"/>
              </a:avLst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7920" bIns="-79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 flipH="1" flipV="1" rot="5400000">
              <a:off x="3902760" y="3269520"/>
              <a:ext cx="69840" cy="115920"/>
            </a:xfrm>
            <a:prstGeom prst="triangle">
              <a:avLst>
                <a:gd name="adj" fmla="val 100000"/>
              </a:avLst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7920" bIns="-79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 flipH="1" flipV="1" rot="9017400">
              <a:off x="3966480" y="1828800"/>
              <a:ext cx="69480" cy="115920"/>
            </a:xfrm>
            <a:prstGeom prst="triangle">
              <a:avLst>
                <a:gd name="adj" fmla="val 100000"/>
              </a:avLst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7920" bIns="-79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 flipH="1" flipV="1" rot="10513800">
              <a:off x="3654360" y="3474000"/>
              <a:ext cx="69840" cy="115920"/>
            </a:xfrm>
            <a:prstGeom prst="triangle">
              <a:avLst>
                <a:gd name="adj" fmla="val 100000"/>
              </a:avLst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7920" bIns="-79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5996160" y="3691080"/>
              <a:ext cx="269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977760" y="4960800"/>
              <a:ext cx="90720" cy="6098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1295280" y="5054760"/>
              <a:ext cx="90720" cy="5158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1616040" y="4943520"/>
              <a:ext cx="90360" cy="62712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1069920" y="4822920"/>
              <a:ext cx="90720" cy="7477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1386000" y="4960800"/>
              <a:ext cx="90360" cy="60984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1703520" y="4892760"/>
              <a:ext cx="90360" cy="6778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2144880" y="4822920"/>
              <a:ext cx="90360" cy="74772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2459160" y="4995720"/>
              <a:ext cx="90360" cy="57492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2774880" y="5167440"/>
              <a:ext cx="90720" cy="4032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2239920" y="4815000"/>
              <a:ext cx="90360" cy="75564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2556000" y="5046840"/>
              <a:ext cx="90360" cy="5238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2868480" y="4917960"/>
              <a:ext cx="90720" cy="6526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3308400" y="5072040"/>
              <a:ext cx="90360" cy="4986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3611520" y="5097600"/>
              <a:ext cx="90360" cy="4730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3929040" y="5364000"/>
              <a:ext cx="90360" cy="2066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3395520" y="5064120"/>
              <a:ext cx="90720" cy="5065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3708360" y="5003640"/>
              <a:ext cx="90360" cy="5670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4021200" y="5218200"/>
              <a:ext cx="90360" cy="35244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 flipV="1">
              <a:off x="1022400" y="4772160"/>
              <a:ext cx="1440" cy="188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992160" y="4772160"/>
              <a:ext cx="604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 flipV="1">
              <a:off x="1339920" y="4908600"/>
              <a:ext cx="1440" cy="1461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1309680" y="4908600"/>
              <a:ext cx="604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 flipV="1">
              <a:off x="1660680" y="4719600"/>
              <a:ext cx="1440" cy="223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630440" y="4719600"/>
              <a:ext cx="6012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 flipV="1">
              <a:off x="1114560" y="4719240"/>
              <a:ext cx="1440" cy="1033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1084320" y="4719600"/>
              <a:ext cx="6012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 flipV="1">
              <a:off x="1430280" y="4736880"/>
              <a:ext cx="1800" cy="223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1400040" y="4737240"/>
              <a:ext cx="604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 flipV="1">
              <a:off x="1747800" y="4659480"/>
              <a:ext cx="0" cy="233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1717560" y="4659480"/>
              <a:ext cx="604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 flipV="1">
              <a:off x="2187720" y="4555800"/>
              <a:ext cx="1440" cy="266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2157480" y="4556160"/>
              <a:ext cx="619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 flipV="1">
              <a:off x="2503440" y="4701960"/>
              <a:ext cx="0" cy="2934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2473200" y="4702320"/>
              <a:ext cx="604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 flipV="1">
              <a:off x="2819520" y="4865760"/>
              <a:ext cx="1440" cy="301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2789280" y="4865760"/>
              <a:ext cx="601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 flipV="1">
              <a:off x="2284560" y="4616280"/>
              <a:ext cx="1440" cy="198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2255760" y="4616280"/>
              <a:ext cx="586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 flipV="1">
              <a:off x="2600280" y="4900680"/>
              <a:ext cx="0" cy="1461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2571840" y="4900680"/>
              <a:ext cx="586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 flipV="1">
              <a:off x="2913120" y="4694040"/>
              <a:ext cx="0" cy="223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2884320" y="4694400"/>
              <a:ext cx="590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 flipV="1">
              <a:off x="3352680" y="4737240"/>
              <a:ext cx="1800" cy="334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3322800" y="4737240"/>
              <a:ext cx="601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 flipV="1">
              <a:off x="3656160" y="4883040"/>
              <a:ext cx="0" cy="214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3625920" y="4883040"/>
              <a:ext cx="6012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 flipV="1">
              <a:off x="3973680" y="5124240"/>
              <a:ext cx="0" cy="2394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3943440" y="5124600"/>
              <a:ext cx="601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 flipV="1">
              <a:off x="3440160" y="4762440"/>
              <a:ext cx="0" cy="301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3409920" y="4762440"/>
              <a:ext cx="604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 flipV="1">
              <a:off x="3753000" y="4815000"/>
              <a:ext cx="1440" cy="188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3722760" y="4815000"/>
              <a:ext cx="601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 flipV="1">
              <a:off x="4065480" y="4908600"/>
              <a:ext cx="1800" cy="309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4035600" y="4908600"/>
              <a:ext cx="601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784080" y="4157640"/>
              <a:ext cx="1800" cy="1413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741240" y="5565600"/>
              <a:ext cx="4284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741240" y="5097600"/>
              <a:ext cx="428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741240" y="4626000"/>
              <a:ext cx="428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741240" y="4152960"/>
              <a:ext cx="428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784080" y="5570640"/>
              <a:ext cx="35290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608040" y="55148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608040" y="50436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608040" y="45705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608040" y="40989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 rot="16200000">
              <a:off x="934920" y="5715720"/>
              <a:ext cx="261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tumo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 rot="16200000">
              <a:off x="1235880" y="5729760"/>
              <a:ext cx="29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vesse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 rot="16200000">
              <a:off x="1519920" y="5763960"/>
              <a:ext cx="358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mucos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 flipH="1">
              <a:off x="876240" y="6080040"/>
              <a:ext cx="1023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 flipV="1">
              <a:off x="1901880" y="6036840"/>
              <a:ext cx="0" cy="42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 flipV="1">
              <a:off x="873000" y="6036840"/>
              <a:ext cx="0" cy="42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1025280" y="6140520"/>
              <a:ext cx="721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R&amp;D MAB 098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 rot="16200000">
              <a:off x="-122040" y="4794480"/>
              <a:ext cx="1058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ng-2 staining intensity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4699800" y="5105520"/>
              <a:ext cx="1173240" cy="48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3618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 =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no stainin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3618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 =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weak stainin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3618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 =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moderate stainin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3618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 =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strong stainin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4699080" y="4100400"/>
              <a:ext cx="2872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3618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n = 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 rot="16200000">
              <a:off x="2100240" y="5715720"/>
              <a:ext cx="261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tumo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 rot="16200000">
              <a:off x="2401200" y="5729760"/>
              <a:ext cx="29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vesse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 rot="16200000">
              <a:off x="2685240" y="5763960"/>
              <a:ext cx="358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mucos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 rot="16200000">
              <a:off x="3249720" y="5715720"/>
              <a:ext cx="261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tumo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 rot="16200000">
              <a:off x="3550320" y="5729760"/>
              <a:ext cx="29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vesse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 rot="16200000">
              <a:off x="3834360" y="5763960"/>
              <a:ext cx="358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mucos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 flipH="1">
              <a:off x="2031480" y="6084720"/>
              <a:ext cx="1024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 flipV="1">
              <a:off x="3057480" y="6041520"/>
              <a:ext cx="0" cy="42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 flipV="1">
              <a:off x="2028960" y="6041520"/>
              <a:ext cx="0" cy="42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2280960" y="6145200"/>
              <a:ext cx="523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SC AB N1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 flipH="1">
              <a:off x="3191040" y="6080040"/>
              <a:ext cx="1023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 flipV="1">
              <a:off x="4216320" y="6036840"/>
              <a:ext cx="0" cy="42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 flipV="1">
              <a:off x="3187800" y="6036840"/>
              <a:ext cx="0" cy="42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3445920" y="6140520"/>
              <a:ext cx="512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SC AB F1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Rectangle 80"/>
            <p:cNvSpPr/>
            <p:nvPr/>
          </p:nvSpPr>
          <p:spPr>
            <a:xfrm>
              <a:off x="4699080" y="4568760"/>
              <a:ext cx="106200" cy="65160"/>
            </a:xfrm>
            <a:prstGeom prst="rect">
              <a:avLst/>
            </a:prstGeom>
            <a:gradFill rotWithShape="0">
              <a:gsLst>
                <a:gs pos="0">
                  <a:srgbClr val="000000"/>
                </a:gs>
                <a:gs pos="100000">
                  <a:srgbClr val="000000"/>
                </a:gs>
              </a:gsLst>
              <a:lin ang="5400000"/>
            </a:gra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lnSpc>
                  <a:spcPct val="9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Rectangle 81"/>
            <p:cNvSpPr/>
            <p:nvPr/>
          </p:nvSpPr>
          <p:spPr>
            <a:xfrm>
              <a:off x="4699080" y="4694400"/>
              <a:ext cx="106200" cy="648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pPr>
                <a:lnSpc>
                  <a:spcPct val="9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TextBox 82"/>
            <p:cNvSpPr/>
            <p:nvPr/>
          </p:nvSpPr>
          <p:spPr>
            <a:xfrm>
              <a:off x="4777560" y="4489560"/>
              <a:ext cx="1203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rimary Ang-2 AB only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TextBox 83"/>
            <p:cNvSpPr/>
            <p:nvPr/>
          </p:nvSpPr>
          <p:spPr>
            <a:xfrm>
              <a:off x="4780080" y="4624560"/>
              <a:ext cx="15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reabsorbed primary Ang-2 A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5869080" y="3476520"/>
              <a:ext cx="523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2682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0 </a:t>
              </a: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1" name=""/>
          <p:cNvGrpSpPr/>
          <p:nvPr/>
        </p:nvGrpSpPr>
        <p:grpSpPr>
          <a:xfrm>
            <a:off x="180720" y="344520"/>
            <a:ext cx="2847960" cy="3607920"/>
            <a:chOff x="180720" y="344520"/>
            <a:chExt cx="2847960" cy="3607920"/>
          </a:xfrm>
        </p:grpSpPr>
        <p:sp>
          <p:nvSpPr>
            <p:cNvPr id="162" name=""/>
            <p:cNvSpPr/>
            <p:nvPr/>
          </p:nvSpPr>
          <p:spPr>
            <a:xfrm>
              <a:off x="183960" y="344520"/>
              <a:ext cx="25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180720" y="2314440"/>
              <a:ext cx="25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Rectangle 3"/>
            <p:cNvSpPr/>
            <p:nvPr/>
          </p:nvSpPr>
          <p:spPr>
            <a:xfrm rot="16200000">
              <a:off x="2689560" y="1604160"/>
              <a:ext cx="85680" cy="745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 vert="eaVer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Rectangle 4"/>
            <p:cNvSpPr/>
            <p:nvPr/>
          </p:nvSpPr>
          <p:spPr>
            <a:xfrm rot="16200000">
              <a:off x="2610360" y="1600920"/>
              <a:ext cx="92160" cy="748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 vert="eaVer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Rectangle 5"/>
            <p:cNvSpPr/>
            <p:nvPr/>
          </p:nvSpPr>
          <p:spPr>
            <a:xfrm rot="16200000">
              <a:off x="2190600" y="1603080"/>
              <a:ext cx="96840" cy="745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 vert="eaVer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Rectangle 6"/>
            <p:cNvSpPr/>
            <p:nvPr/>
          </p:nvSpPr>
          <p:spPr>
            <a:xfrm rot="16200000">
              <a:off x="2120760" y="1608120"/>
              <a:ext cx="85680" cy="763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 vert="eaVer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Rectangle 7"/>
            <p:cNvSpPr/>
            <p:nvPr/>
          </p:nvSpPr>
          <p:spPr>
            <a:xfrm rot="16200000">
              <a:off x="2440440" y="1609920"/>
              <a:ext cx="81000" cy="763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 vert="eaVer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Rectangle 8"/>
            <p:cNvSpPr/>
            <p:nvPr/>
          </p:nvSpPr>
          <p:spPr>
            <a:xfrm rot="16200000">
              <a:off x="2372760" y="1617480"/>
              <a:ext cx="68400" cy="745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 vert="eaVer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Rectangle 12"/>
            <p:cNvSpPr/>
            <p:nvPr/>
          </p:nvSpPr>
          <p:spPr>
            <a:xfrm rot="16200000">
              <a:off x="1094040" y="1632600"/>
              <a:ext cx="28800" cy="745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 vert="eaVer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Rectangle 13"/>
            <p:cNvSpPr/>
            <p:nvPr/>
          </p:nvSpPr>
          <p:spPr>
            <a:xfrm rot="16200000">
              <a:off x="941760" y="1600920"/>
              <a:ext cx="92160" cy="745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 vert="eaVer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Rectangle 14"/>
            <p:cNvSpPr/>
            <p:nvPr/>
          </p:nvSpPr>
          <p:spPr>
            <a:xfrm rot="16200000">
              <a:off x="822600" y="1602000"/>
              <a:ext cx="87480" cy="763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 vert="eaVer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Rectangle 16"/>
            <p:cNvSpPr/>
            <p:nvPr/>
          </p:nvSpPr>
          <p:spPr>
            <a:xfrm rot="16200000">
              <a:off x="1026000" y="1121040"/>
              <a:ext cx="1055880" cy="795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y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Rectangle 34"/>
            <p:cNvSpPr/>
            <p:nvPr/>
          </p:nvSpPr>
          <p:spPr>
            <a:xfrm rot="16200000">
              <a:off x="2539800" y="1823760"/>
              <a:ext cx="334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W94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Rectangle 36"/>
            <p:cNvSpPr/>
            <p:nvPr/>
          </p:nvSpPr>
          <p:spPr>
            <a:xfrm rot="16200000">
              <a:off x="2080080" y="1788120"/>
              <a:ext cx="25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DLD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Rectangle 40"/>
            <p:cNvSpPr/>
            <p:nvPr/>
          </p:nvSpPr>
          <p:spPr>
            <a:xfrm rot="16200000">
              <a:off x="1837800" y="1782720"/>
              <a:ext cx="249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T2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Rectangle 42"/>
            <p:cNvSpPr/>
            <p:nvPr/>
          </p:nvSpPr>
          <p:spPr>
            <a:xfrm rot="16200000">
              <a:off x="2269800" y="1837800"/>
              <a:ext cx="357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LS174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Rectangle 48"/>
            <p:cNvSpPr/>
            <p:nvPr/>
          </p:nvSpPr>
          <p:spPr>
            <a:xfrm rot="16200000">
              <a:off x="1414080" y="1836000"/>
              <a:ext cx="357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UVE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Rectangle 51"/>
            <p:cNvSpPr/>
            <p:nvPr/>
          </p:nvSpPr>
          <p:spPr>
            <a:xfrm rot="17238000">
              <a:off x="793440" y="1778040"/>
              <a:ext cx="122400" cy="1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Rectangle 52"/>
            <p:cNvSpPr/>
            <p:nvPr/>
          </p:nvSpPr>
          <p:spPr>
            <a:xfrm rot="16200000">
              <a:off x="1946160" y="1603080"/>
              <a:ext cx="96840" cy="745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 vert="eaVer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Rectangle 53"/>
            <p:cNvSpPr/>
            <p:nvPr/>
          </p:nvSpPr>
          <p:spPr>
            <a:xfrm rot="16200000">
              <a:off x="1877040" y="1608840"/>
              <a:ext cx="85680" cy="748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 vert="eaVer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Line 19"/>
            <p:cNvSpPr/>
            <p:nvPr/>
          </p:nvSpPr>
          <p:spPr>
            <a:xfrm flipV="1">
              <a:off x="722160" y="652320"/>
              <a:ext cx="0" cy="1092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Line 20"/>
            <p:cNvSpPr/>
            <p:nvPr/>
          </p:nvSpPr>
          <p:spPr>
            <a:xfrm flipV="1">
              <a:off x="682560" y="1345680"/>
              <a:ext cx="3960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Line 21"/>
            <p:cNvSpPr/>
            <p:nvPr/>
          </p:nvSpPr>
          <p:spPr>
            <a:xfrm flipV="1">
              <a:off x="682560" y="998640"/>
              <a:ext cx="3960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Line 22"/>
            <p:cNvSpPr/>
            <p:nvPr/>
          </p:nvSpPr>
          <p:spPr>
            <a:xfrm flipV="1">
              <a:off x="682560" y="651960"/>
              <a:ext cx="3960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Rectangle 27"/>
            <p:cNvSpPr/>
            <p:nvPr/>
          </p:nvSpPr>
          <p:spPr>
            <a:xfrm flipH="1">
              <a:off x="595800" y="16304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Rectangle 28"/>
            <p:cNvSpPr/>
            <p:nvPr/>
          </p:nvSpPr>
          <p:spPr>
            <a:xfrm flipH="1">
              <a:off x="510480" y="128592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Rectangle 29"/>
            <p:cNvSpPr/>
            <p:nvPr/>
          </p:nvSpPr>
          <p:spPr>
            <a:xfrm flipH="1">
              <a:off x="510480" y="94140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Rectangle 160"/>
            <p:cNvSpPr/>
            <p:nvPr/>
          </p:nvSpPr>
          <p:spPr>
            <a:xfrm flipH="1">
              <a:off x="421560" y="595440"/>
              <a:ext cx="230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&gt; 3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Rectangle 57"/>
            <p:cNvSpPr/>
            <p:nvPr/>
          </p:nvSpPr>
          <p:spPr>
            <a:xfrm rot="16200000">
              <a:off x="59760" y="1098360"/>
              <a:ext cx="608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ng-2 [ng/ml]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Rectangle 74"/>
            <p:cNvSpPr/>
            <p:nvPr/>
          </p:nvSpPr>
          <p:spPr>
            <a:xfrm rot="20558400">
              <a:off x="1397880" y="755640"/>
              <a:ext cx="104760" cy="54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pPr>
                <a:lnSpc>
                  <a:spcPct val="9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Rectangle 76"/>
            <p:cNvSpPr/>
            <p:nvPr/>
          </p:nvSpPr>
          <p:spPr>
            <a:xfrm rot="20558400">
              <a:off x="1263240" y="763560"/>
              <a:ext cx="104760" cy="54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pPr>
                <a:lnSpc>
                  <a:spcPct val="9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Rectangle 77"/>
            <p:cNvSpPr/>
            <p:nvPr/>
          </p:nvSpPr>
          <p:spPr>
            <a:xfrm rot="20558400">
              <a:off x="674280" y="774720"/>
              <a:ext cx="104760" cy="54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pPr>
                <a:lnSpc>
                  <a:spcPct val="9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Straight Connector 71"/>
            <p:cNvSpPr/>
            <p:nvPr/>
          </p:nvSpPr>
          <p:spPr>
            <a:xfrm flipV="1">
              <a:off x="680760" y="764640"/>
              <a:ext cx="84240" cy="24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Straight Connector 72"/>
            <p:cNvSpPr/>
            <p:nvPr/>
          </p:nvSpPr>
          <p:spPr>
            <a:xfrm flipV="1">
              <a:off x="682560" y="813960"/>
              <a:ext cx="83880" cy="25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Rectangle 80"/>
            <p:cNvSpPr/>
            <p:nvPr/>
          </p:nvSpPr>
          <p:spPr>
            <a:xfrm>
              <a:off x="2349360" y="646200"/>
              <a:ext cx="106200" cy="65160"/>
            </a:xfrm>
            <a:prstGeom prst="rect">
              <a:avLst/>
            </a:prstGeom>
            <a:gradFill rotWithShape="0">
              <a:gsLst>
                <a:gs pos="0">
                  <a:srgbClr val="000000"/>
                </a:gs>
                <a:gs pos="100000">
                  <a:srgbClr val="000000"/>
                </a:gs>
              </a:gsLst>
              <a:lin ang="5400000"/>
            </a:gra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lnSpc>
                  <a:spcPct val="9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Rectangle 81"/>
            <p:cNvSpPr/>
            <p:nvPr/>
          </p:nvSpPr>
          <p:spPr>
            <a:xfrm>
              <a:off x="2349360" y="762120"/>
              <a:ext cx="106200" cy="64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pPr>
                <a:lnSpc>
                  <a:spcPct val="9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TextBox 82"/>
            <p:cNvSpPr/>
            <p:nvPr/>
          </p:nvSpPr>
          <p:spPr>
            <a:xfrm>
              <a:off x="2428920" y="585720"/>
              <a:ext cx="599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ormoxi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TextBox 83"/>
            <p:cNvSpPr/>
            <p:nvPr/>
          </p:nvSpPr>
          <p:spPr>
            <a:xfrm>
              <a:off x="2428920" y="711360"/>
              <a:ext cx="532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ypoxi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Rectangle 48"/>
            <p:cNvSpPr/>
            <p:nvPr/>
          </p:nvSpPr>
          <p:spPr>
            <a:xfrm rot="16200000">
              <a:off x="743760" y="1786680"/>
              <a:ext cx="256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RPM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Rectangle 48"/>
            <p:cNvSpPr/>
            <p:nvPr/>
          </p:nvSpPr>
          <p:spPr>
            <a:xfrm rot="16200000">
              <a:off x="829440" y="1814400"/>
              <a:ext cx="313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DME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Rectangle 48"/>
            <p:cNvSpPr/>
            <p:nvPr/>
          </p:nvSpPr>
          <p:spPr>
            <a:xfrm rot="16200000">
              <a:off x="1005480" y="1775520"/>
              <a:ext cx="234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EG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Straight Connector 175"/>
            <p:cNvSpPr/>
            <p:nvPr/>
          </p:nvSpPr>
          <p:spPr>
            <a:xfrm>
              <a:off x="718920" y="1584360"/>
              <a:ext cx="2168640" cy="1440"/>
            </a:xfrm>
            <a:prstGeom prst="line">
              <a:avLst/>
            </a:prstGeom>
            <a:ln w="6480">
              <a:solidFill>
                <a:srgbClr val="000000"/>
              </a:solidFill>
              <a:prstDash val="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Rectangle 16"/>
            <p:cNvSpPr/>
            <p:nvPr/>
          </p:nvSpPr>
          <p:spPr>
            <a:xfrm rot="16200000">
              <a:off x="853560" y="1120320"/>
              <a:ext cx="1055880" cy="80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840" bIns="33840" anchor="t" vert="eaVer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Rectangle 16"/>
            <p:cNvSpPr/>
            <p:nvPr/>
          </p:nvSpPr>
          <p:spPr>
            <a:xfrm rot="16200000">
              <a:off x="1105200" y="1119240"/>
              <a:ext cx="1055880" cy="82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 vert="eaVer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Line 26"/>
            <p:cNvSpPr/>
            <p:nvPr/>
          </p:nvSpPr>
          <p:spPr>
            <a:xfrm flipV="1">
              <a:off x="718920" y="1685520"/>
              <a:ext cx="216864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Parallelogram 132"/>
            <p:cNvSpPr/>
            <p:nvPr/>
          </p:nvSpPr>
          <p:spPr>
            <a:xfrm rot="9886200">
              <a:off x="1315440" y="763200"/>
              <a:ext cx="119160" cy="42840"/>
            </a:xfrm>
            <a:prstGeom prst="parallelogram">
              <a:avLst>
                <a:gd name="adj" fmla="val 30996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Parallelogram 133"/>
            <p:cNvSpPr/>
            <p:nvPr/>
          </p:nvSpPr>
          <p:spPr>
            <a:xfrm rot="9886200">
              <a:off x="1482120" y="757080"/>
              <a:ext cx="119160" cy="43200"/>
            </a:xfrm>
            <a:prstGeom prst="parallelogram">
              <a:avLst>
                <a:gd name="adj" fmla="val 31491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Parallelogram 134"/>
            <p:cNvSpPr/>
            <p:nvPr/>
          </p:nvSpPr>
          <p:spPr>
            <a:xfrm rot="9886200">
              <a:off x="1582200" y="725040"/>
              <a:ext cx="119160" cy="42840"/>
            </a:xfrm>
            <a:prstGeom prst="parallelogram">
              <a:avLst>
                <a:gd name="adj" fmla="val 31756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Rectangle 48"/>
            <p:cNvSpPr/>
            <p:nvPr/>
          </p:nvSpPr>
          <p:spPr>
            <a:xfrm rot="16200000">
              <a:off x="1235880" y="1812600"/>
              <a:ext cx="307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11" name="Picture 230" descr="ANG-2 WESTERN CONTROL.png"/>
            <p:cNvPicPr/>
            <p:nvPr/>
          </p:nvPicPr>
          <p:blipFill>
            <a:blip r:embed="rId1"/>
            <a:srcRect l="0" t="19184" r="43232" b="19184"/>
            <a:stretch/>
          </p:blipFill>
          <p:spPr>
            <a:xfrm>
              <a:off x="2430360" y="3084480"/>
              <a:ext cx="422280" cy="768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12" name="Rectangle 231"/>
            <p:cNvSpPr/>
            <p:nvPr/>
          </p:nvSpPr>
          <p:spPr>
            <a:xfrm flipH="1">
              <a:off x="2638080" y="3087720"/>
              <a:ext cx="214560" cy="7635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Text Box 15"/>
            <p:cNvSpPr/>
            <p:nvPr/>
          </p:nvSpPr>
          <p:spPr>
            <a:xfrm rot="16200000">
              <a:off x="2526120" y="2772360"/>
              <a:ext cx="487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Text Box 25"/>
            <p:cNvSpPr/>
            <p:nvPr/>
          </p:nvSpPr>
          <p:spPr>
            <a:xfrm>
              <a:off x="2221560" y="3592440"/>
              <a:ext cx="487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-act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Text Box 28"/>
            <p:cNvSpPr/>
            <p:nvPr/>
          </p:nvSpPr>
          <p:spPr>
            <a:xfrm>
              <a:off x="2238120" y="3370320"/>
              <a:ext cx="452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ng-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Text Box 46"/>
            <p:cNvSpPr/>
            <p:nvPr/>
          </p:nvSpPr>
          <p:spPr>
            <a:xfrm>
              <a:off x="391680" y="3035160"/>
              <a:ext cx="349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3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Text Box 47"/>
            <p:cNvSpPr/>
            <p:nvPr/>
          </p:nvSpPr>
          <p:spPr>
            <a:xfrm>
              <a:off x="391680" y="3146400"/>
              <a:ext cx="349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Text Box 48"/>
            <p:cNvSpPr/>
            <p:nvPr/>
          </p:nvSpPr>
          <p:spPr>
            <a:xfrm>
              <a:off x="448560" y="324648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Text Box 49"/>
            <p:cNvSpPr/>
            <p:nvPr/>
          </p:nvSpPr>
          <p:spPr>
            <a:xfrm>
              <a:off x="448560" y="340056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Text Box 50"/>
            <p:cNvSpPr/>
            <p:nvPr/>
          </p:nvSpPr>
          <p:spPr>
            <a:xfrm>
              <a:off x="448560" y="357192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Text Box 51"/>
            <p:cNvSpPr/>
            <p:nvPr/>
          </p:nvSpPr>
          <p:spPr>
            <a:xfrm>
              <a:off x="448560" y="373680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Text Box 5"/>
            <p:cNvSpPr/>
            <p:nvPr/>
          </p:nvSpPr>
          <p:spPr>
            <a:xfrm rot="16200000">
              <a:off x="772200" y="2802600"/>
              <a:ext cx="429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T2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Text Box 6"/>
            <p:cNvSpPr/>
            <p:nvPr/>
          </p:nvSpPr>
          <p:spPr>
            <a:xfrm rot="16200000">
              <a:off x="981360" y="2796120"/>
              <a:ext cx="439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DLD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Text Box 7"/>
            <p:cNvSpPr/>
            <p:nvPr/>
          </p:nvSpPr>
          <p:spPr>
            <a:xfrm rot="16200000">
              <a:off x="1146960" y="2747520"/>
              <a:ext cx="53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LS174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Text Box 9"/>
            <p:cNvSpPr/>
            <p:nvPr/>
          </p:nvSpPr>
          <p:spPr>
            <a:xfrm rot="16200000">
              <a:off x="1374480" y="2759400"/>
              <a:ext cx="514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W94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Text Box 10"/>
            <p:cNvSpPr/>
            <p:nvPr/>
          </p:nvSpPr>
          <p:spPr>
            <a:xfrm rot="16200000">
              <a:off x="1864440" y="2746080"/>
              <a:ext cx="53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UVE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Text Box 17"/>
            <p:cNvSpPr/>
            <p:nvPr/>
          </p:nvSpPr>
          <p:spPr>
            <a:xfrm>
              <a:off x="870840" y="2432160"/>
              <a:ext cx="924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olon carcinom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28" name="Picture 221" descr="western blot2.png"/>
            <p:cNvPicPr/>
            <p:nvPr/>
          </p:nvPicPr>
          <p:blipFill>
            <a:blip r:embed="rId2"/>
            <a:srcRect l="0" t="0" r="42125" b="0"/>
            <a:stretch/>
          </p:blipFill>
          <p:spPr>
            <a:xfrm>
              <a:off x="671400" y="3060720"/>
              <a:ext cx="1604880" cy="828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29" name="Rectangle 222"/>
            <p:cNvSpPr/>
            <p:nvPr/>
          </p:nvSpPr>
          <p:spPr>
            <a:xfrm>
              <a:off x="815760" y="3089160"/>
              <a:ext cx="1457280" cy="7714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817200" y="2627280"/>
              <a:ext cx="0" cy="46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1725480" y="2627280"/>
              <a:ext cx="0" cy="46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817200" y="2627280"/>
              <a:ext cx="908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15T18:52:51Z</dcterms:created>
  <dc:creator>Valentin Goede</dc:creator>
  <dc:description/>
  <dc:language>en-US</dc:language>
  <cp:lastModifiedBy>Valentin Goede</cp:lastModifiedBy>
  <dcterms:modified xsi:type="dcterms:W3CDTF">2010-07-18T19:49:50Z</dcterms:modified>
  <cp:revision>65</cp:revision>
  <dc:subject/>
  <dc:title>Folie 1</dc:title>
</cp:coreProperties>
</file>